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9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8" autoAdjust="0"/>
    <p:restoredTop sz="94660"/>
  </p:normalViewPr>
  <p:slideViewPr>
    <p:cSldViewPr snapToGrid="0">
      <p:cViewPr>
        <p:scale>
          <a:sx n="77" d="100"/>
          <a:sy n="77" d="100"/>
        </p:scale>
        <p:origin x="-1896" y="-17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75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2905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9117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7868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740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6638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7497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284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2443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799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9546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91DB08-6CAB-43A3-989A-42582BE97F5E}" type="datetimeFigureOut">
              <a:rPr kumimoji="1" lang="ja-JP" altLang="en-US" smtClean="0"/>
              <a:t>2017/9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F88F1-E114-4E46-9819-F738DFD7FB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54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1531" y="3399337"/>
            <a:ext cx="4248150" cy="2381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8268" y="5823587"/>
            <a:ext cx="4248150" cy="2381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2075" y="1015365"/>
            <a:ext cx="4248150" cy="2381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正方形/長方形 7"/>
          <p:cNvSpPr/>
          <p:nvPr/>
        </p:nvSpPr>
        <p:spPr>
          <a:xfrm rot="16200000">
            <a:off x="53767" y="1992773"/>
            <a:ext cx="275383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T thickness</a:t>
            </a:r>
            <a:endParaRPr lang="en-US" altLang="ja-JP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m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2110190" y="8358236"/>
            <a:ext cx="24160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HbA1c (%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 rot="16200000">
            <a:off x="312397" y="4466390"/>
            <a:ext cx="223657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T area</a:t>
            </a:r>
            <a:endParaRPr lang="en-US" altLang="ja-JP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mm</a:t>
            </a:r>
            <a:r>
              <a:rPr lang="en-US" altLang="ja-JP" baseline="30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 rot="16200000">
            <a:off x="271777" y="6850421"/>
            <a:ext cx="231781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 SAT 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endParaRPr lang="en-US" altLang="ja-JP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m</a:t>
            </a:r>
            <a:r>
              <a:rPr lang="en-US" altLang="ja-JP" baseline="30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434840" y="119272"/>
            <a:ext cx="24231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file 1:  Figure S1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143096" y="3101269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=0.2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143096" y="5552025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=0.40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143096" y="7838026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=0.9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3604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1491" y="757917"/>
            <a:ext cx="4248150" cy="2381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正方形/長方形 13"/>
          <p:cNvSpPr/>
          <p:nvPr/>
        </p:nvSpPr>
        <p:spPr>
          <a:xfrm>
            <a:off x="2176487" y="8021903"/>
            <a:ext cx="275383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T thickness</a:t>
            </a:r>
            <a:endParaRPr lang="en-US" altLang="ja-JP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m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1491" y="3120118"/>
            <a:ext cx="4248150" cy="2381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1489" y="5493202"/>
            <a:ext cx="4248150" cy="2381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テキスト ボックス 20"/>
          <p:cNvSpPr txBox="1"/>
          <p:nvPr/>
        </p:nvSpPr>
        <p:spPr>
          <a:xfrm>
            <a:off x="4434840" y="119272"/>
            <a:ext cx="24231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Additional file 1:  Figure S2</a:t>
            </a:r>
            <a:endParaRPr lang="ja-JP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 rot="16200000">
            <a:off x="535551" y="1667289"/>
            <a:ext cx="223657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VAT area</a:t>
            </a:r>
          </a:p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m</a:t>
            </a:r>
            <a:r>
              <a:rPr lang="en-US" altLang="ja-JP" baseline="30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 rot="16200000">
            <a:off x="526992" y="4065976"/>
            <a:ext cx="225369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T area</a:t>
            </a:r>
            <a:endParaRPr lang="en-US" altLang="ja-JP" dirty="0" smtClean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mm</a:t>
            </a:r>
            <a:r>
              <a:rPr lang="en-US" altLang="ja-JP" baseline="30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正方形/長方形 21"/>
          <p:cNvSpPr/>
          <p:nvPr/>
        </p:nvSpPr>
        <p:spPr>
          <a:xfrm rot="16200000">
            <a:off x="343222" y="6521736"/>
            <a:ext cx="262123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nge in Body weight </a:t>
            </a:r>
          </a:p>
          <a:p>
            <a:pPr algn="ctr"/>
            <a:r>
              <a:rPr lang="en-US" altLang="ja-JP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Kg)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178108" y="2804707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=0.7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178108" y="4958902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=0.8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178108" y="7607368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P=0.7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3581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6</TotalTime>
  <Words>75</Words>
  <Application>Microsoft Office PowerPoint</Application>
  <PresentationFormat>画面に合わせる (4:3)</PresentationFormat>
  <Paragraphs>23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gi</dc:creator>
  <cp:lastModifiedBy>八木</cp:lastModifiedBy>
  <cp:revision>26</cp:revision>
  <dcterms:created xsi:type="dcterms:W3CDTF">2016-12-22T09:52:07Z</dcterms:created>
  <dcterms:modified xsi:type="dcterms:W3CDTF">2017-09-25T07:28:06Z</dcterms:modified>
</cp:coreProperties>
</file>